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301" r:id="rId2"/>
    <p:sldId id="303" r:id="rId3"/>
    <p:sldId id="304" r:id="rId4"/>
    <p:sldId id="277" r:id="rId5"/>
    <p:sldId id="307" r:id="rId6"/>
    <p:sldId id="305" r:id="rId7"/>
    <p:sldId id="306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7EE05"/>
    <a:srgbClr val="CCCCCC"/>
    <a:srgbClr val="FFFFBF"/>
    <a:srgbClr val="FFFF00"/>
    <a:srgbClr val="FF40FF"/>
    <a:srgbClr val="7FC97F"/>
    <a:srgbClr val="AEAEAE"/>
    <a:srgbClr val="2B474E"/>
    <a:srgbClr val="7FE7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524"/>
    <p:restoredTop sz="94673"/>
  </p:normalViewPr>
  <p:slideViewPr>
    <p:cSldViewPr snapToGrid="0">
      <p:cViewPr varScale="1">
        <p:scale>
          <a:sx n="89" d="100"/>
          <a:sy n="89" d="100"/>
        </p:scale>
        <p:origin x="26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49A78A-56A4-B74B-A707-E6A08FAA94AE}" type="datetimeFigureOut">
              <a:t>2024/7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09C74B-BE96-F446-BFCD-C1C979EE518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6357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09C74B-BE96-F446-BFCD-C1C979EE5184}" type="slidenum">
              <a:rPr lang="en-US" altLang="ja-JP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3415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09C74B-BE96-F446-BFCD-C1C979EE5184}" type="slidenum">
              <a:rPr lang="en-US" altLang="ja-JP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96958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09C74B-BE96-F446-BFCD-C1C979EE5184}" type="slidenum">
              <a:rPr lang="en-US" altLang="ja-JP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270387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09C74B-BE96-F446-BFCD-C1C979EE5184}" type="slidenum">
              <a:rPr lang="en-US" altLang="ja-JP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907880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09C74B-BE96-F446-BFCD-C1C979EE5184}" type="slidenum">
              <a:rPr lang="en-US" altLang="ja-JP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09252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09C74B-BE96-F446-BFCD-C1C979EE5184}" type="slidenum">
              <a:rPr lang="en-US" altLang="ja-JP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04513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09C74B-BE96-F446-BFCD-C1C979EE5184}" type="slidenum">
              <a:rPr lang="en-US" altLang="ja-JP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22624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5570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0737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444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89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2675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9342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941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800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4308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472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906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5E69E5-AFE2-EA40-A688-4BF97797348E}" type="datetimeFigureOut">
              <a:t>2024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F85C4-A55A-A248-8231-3927F222597C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62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A326E64-C952-1495-E2C0-2FC0F2FA1414}"/>
              </a:ext>
            </a:extLst>
          </p:cNvPr>
          <p:cNvSpPr txBox="1"/>
          <p:nvPr/>
        </p:nvSpPr>
        <p:spPr>
          <a:xfrm>
            <a:off x="341439" y="2080753"/>
            <a:ext cx="6163235" cy="1727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Supplementary Fig. 1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Shared sequence information between SAGs, metagenomes (MG), and MAGs.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>
                <a:latin typeface="Helvetica" pitchFamily="2" charset="0"/>
              </a:rPr>
              <a:t>(left) Overlap of the contigs of fecal metagenomes (gray) and fecal SAGs (green) based on BLASTn. A mean of 49% of the SAG contigs were aligned to the metagenomic contigs. (right) Overlap of the contigs of fecal MAGs (magenta) and fecal SAGs (green). A mean of 30.6% of the SAG contigs were aligned to the MAG contigs. </a:t>
            </a:r>
            <a:endParaRPr kumimoji="1" lang="ja-JP" altLang="en-US" sz="1200">
              <a:latin typeface="Helvetica" pitchFamily="2" charset="0"/>
            </a:endParaRPr>
          </a:p>
        </p:txBody>
      </p:sp>
      <p:pic>
        <p:nvPicPr>
          <p:cNvPr id="7" name="図 6" descr="グラフ, ウォーターフォール図&#10;&#10;自動的に生成された説明">
            <a:extLst>
              <a:ext uri="{FF2B5EF4-FFF2-40B4-BE49-F238E27FC236}">
                <a16:creationId xmlns:a16="http://schemas.microsoft.com/office/drawing/2014/main" id="{468C99EE-D627-7B5C-F79D-96A5AB631E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161" y="772653"/>
            <a:ext cx="6375400" cy="130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87037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A317340-53D6-4992-1857-C6A674D5E559}"/>
              </a:ext>
            </a:extLst>
          </p:cNvPr>
          <p:cNvSpPr txBox="1"/>
          <p:nvPr/>
        </p:nvSpPr>
        <p:spPr>
          <a:xfrm>
            <a:off x="338152" y="6495690"/>
            <a:ext cx="6266163" cy="20045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Supplementary Fig. 2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Counts (upper) and cluster numbers (lower) for mobile genetic elements (plasmid and phage) and antimicrobial resistance genes in oral SAGs, fecal SAGs, and fecal MAGs.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>
                <a:latin typeface="Helvetica" pitchFamily="2" charset="0"/>
              </a:rPr>
              <a:t>Clustering was performed by MMseqs2 at 90% similarity and coverage. The legends detail the medical condition associated with each sample (Healthy; BC, breast cancer; CRC, colorectal cancer; LC, lung cancer; IBS, irritable bowel syndrome; UC, ulcerative colitis). </a:t>
            </a:r>
            <a:endParaRPr kumimoji="1" lang="ja-JP" altLang="en-US" sz="1200">
              <a:latin typeface="Helvetica" pitchFamily="2" charset="0"/>
            </a:endParaRPr>
          </a:p>
        </p:txBody>
      </p:sp>
      <p:pic>
        <p:nvPicPr>
          <p:cNvPr id="47" name="図 46" descr="タイムライン が含まれている画像&#10;&#10;自動的に生成された説明">
            <a:extLst>
              <a:ext uri="{FF2B5EF4-FFF2-40B4-BE49-F238E27FC236}">
                <a16:creationId xmlns:a16="http://schemas.microsoft.com/office/drawing/2014/main" id="{18335DC1-A362-1C3B-FC0C-8A0DCBA6FA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685" y="1072790"/>
            <a:ext cx="6299200" cy="5422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9856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CF99E66-D603-273C-072E-07400398D5D3}"/>
              </a:ext>
            </a:extLst>
          </p:cNvPr>
          <p:cNvSpPr txBox="1"/>
          <p:nvPr/>
        </p:nvSpPr>
        <p:spPr>
          <a:xfrm>
            <a:off x="301314" y="5237689"/>
            <a:ext cx="6266163" cy="896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Supplementary Fig. 3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Heatmap for the presence of antibiotic resistance genes in oral SAGs, fecal SAGs, metagenomes, and MAGs.</a:t>
            </a:r>
          </a:p>
        </p:txBody>
      </p:sp>
      <p:pic>
        <p:nvPicPr>
          <p:cNvPr id="7" name="図 6" descr="タイムライン&#10;&#10;自動的に生成された説明">
            <a:extLst>
              <a:ext uri="{FF2B5EF4-FFF2-40B4-BE49-F238E27FC236}">
                <a16:creationId xmlns:a16="http://schemas.microsoft.com/office/drawing/2014/main" id="{7C6BFFDE-22B1-0111-394C-E51743BF97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850" y="919689"/>
            <a:ext cx="6464300" cy="431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28289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8AE1081-1920-D773-DE66-707BDD295693}"/>
              </a:ext>
            </a:extLst>
          </p:cNvPr>
          <p:cNvSpPr txBox="1"/>
          <p:nvPr/>
        </p:nvSpPr>
        <p:spPr>
          <a:xfrm>
            <a:off x="332124" y="6045007"/>
            <a:ext cx="6266163" cy="20045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Supplementary Fig. 4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Comparison of the whole ARG profiles of fecal SAG and MAG.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>
                <a:latin typeface="Helvetica" pitchFamily="2" charset="0"/>
              </a:rPr>
              <a:t>Distribution and genetic context of ARGs in genomes (including MGEs and chromosome) are visualized as pie charts for fecal MAGs (top) and SAGs (bottom). The x-axis labels detail the medical condition associated with each participant (Healthy; BC, breast cancer; CRC, colorectal cancer; LC, lung cancer; IBS, irritable bowel syndrome; UC, ulcerative colitis). The y-axis shows classes of ARGs.</a:t>
            </a:r>
          </a:p>
        </p:txBody>
      </p:sp>
      <p:pic>
        <p:nvPicPr>
          <p:cNvPr id="20" name="図 19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8911DC7E-EDCD-41A9-184A-F94C9D7C9A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9387" y="663382"/>
            <a:ext cx="6438900" cy="5448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66032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9EE30FA8-BB14-859E-EF1D-EBD92F1E328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2671" b="8315"/>
          <a:stretch/>
        </p:blipFill>
        <p:spPr>
          <a:xfrm>
            <a:off x="0" y="1354148"/>
            <a:ext cx="6858000" cy="3152633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B89EA48-671D-F437-FA92-7539F9723C9B}"/>
              </a:ext>
            </a:extLst>
          </p:cNvPr>
          <p:cNvSpPr txBox="1"/>
          <p:nvPr/>
        </p:nvSpPr>
        <p:spPr>
          <a:xfrm>
            <a:off x="0" y="4643235"/>
            <a:ext cx="6858000" cy="22815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Supplementary Fig. 5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Alignment of 52 nucleotide sequences predicted as plasmids detected from the nine genera of QLF055 SAGs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>
                <a:latin typeface="Helvetica" pitchFamily="2" charset="0"/>
              </a:rPr>
              <a:t>An alignment of 52 nucleotide sequences from 9 genera was performed using MAFFT-L-INS-i. The upper panel shows a partial alignment from 1 nt to 120 nt, while the lower barcode represents the entire alignment. The alignment revealed several gaps at the contig ends, but aside from these gaps, the sequences were 100% identical. MSAViewer (Yachdav et al. 2016) was used to visualize the alignment.</a:t>
            </a:r>
          </a:p>
        </p:txBody>
      </p:sp>
    </p:spTree>
    <p:extLst>
      <p:ext uri="{BB962C8B-B14F-4D97-AF65-F5344CB8AC3E}">
        <p14:creationId xmlns:p14="http://schemas.microsoft.com/office/powerpoint/2010/main" val="13427341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E5DDE5B-9F7D-378E-B977-5103D4EE9D56}"/>
              </a:ext>
            </a:extLst>
          </p:cNvPr>
          <p:cNvSpPr txBox="1"/>
          <p:nvPr/>
        </p:nvSpPr>
        <p:spPr>
          <a:xfrm>
            <a:off x="156395" y="8880101"/>
            <a:ext cx="6266163" cy="6195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Supplementary Fig. 6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Distribution of ARGs in MGEs for all participants classified by disease </a:t>
            </a:r>
          </a:p>
        </p:txBody>
      </p:sp>
      <p:pic>
        <p:nvPicPr>
          <p:cNvPr id="38" name="図 37" descr="ダイアグラム&#10;&#10;自動的に生成された説明">
            <a:extLst>
              <a:ext uri="{FF2B5EF4-FFF2-40B4-BE49-F238E27FC236}">
                <a16:creationId xmlns:a16="http://schemas.microsoft.com/office/drawing/2014/main" id="{F1EB6023-36D0-5AFE-A370-5BD7152417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100" y="406370"/>
            <a:ext cx="6273800" cy="815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651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78E26E5-3EB9-C85A-B528-FE8298318DC1}"/>
              </a:ext>
            </a:extLst>
          </p:cNvPr>
          <p:cNvSpPr txBox="1"/>
          <p:nvPr/>
        </p:nvSpPr>
        <p:spPr>
          <a:xfrm>
            <a:off x="156395" y="8880101"/>
            <a:ext cx="6266163" cy="6195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(continued) Supplementary Fig. 6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 b="1">
                <a:latin typeface="Helvetica" pitchFamily="2" charset="0"/>
              </a:rPr>
              <a:t>Distribution of ARGs in MGEs for all participants classified by disease</a:t>
            </a:r>
          </a:p>
        </p:txBody>
      </p:sp>
      <p:pic>
        <p:nvPicPr>
          <p:cNvPr id="9" name="図 8" descr="ダイアグラム, 概略図&#10;&#10;自動的に生成された説明">
            <a:extLst>
              <a:ext uri="{FF2B5EF4-FFF2-40B4-BE49-F238E27FC236}">
                <a16:creationId xmlns:a16="http://schemas.microsoft.com/office/drawing/2014/main" id="{C1199D86-B5E1-B143-C312-644E1969EB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600" y="406370"/>
            <a:ext cx="6146800" cy="8343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7085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3370</TotalTime>
  <Words>432</Words>
  <Application>Microsoft Macintosh PowerPoint</Application>
  <PresentationFormat>A4 210 x 297 mm</PresentationFormat>
  <Paragraphs>25</Paragraphs>
  <Slides>7</Slides>
  <Notes>7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etsuro Kawano-Sugaya</dc:creator>
  <cp:lastModifiedBy>Tetsuro Kawano-Sugaya</cp:lastModifiedBy>
  <cp:revision>743</cp:revision>
  <dcterms:created xsi:type="dcterms:W3CDTF">2023-05-31T21:58:17Z</dcterms:created>
  <dcterms:modified xsi:type="dcterms:W3CDTF">2024-07-27T07:32:14Z</dcterms:modified>
</cp:coreProperties>
</file>